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3" r:id="rId2"/>
  </p:sldMasterIdLst>
  <p:notesMasterIdLst>
    <p:notesMasterId r:id="rId21"/>
  </p:notesMasterIdLst>
  <p:sldIdLst>
    <p:sldId id="258" r:id="rId3"/>
    <p:sldId id="367" r:id="rId4"/>
    <p:sldId id="260" r:id="rId5"/>
    <p:sldId id="369" r:id="rId6"/>
    <p:sldId id="370" r:id="rId7"/>
    <p:sldId id="371" r:id="rId8"/>
    <p:sldId id="372" r:id="rId9"/>
    <p:sldId id="373" r:id="rId10"/>
    <p:sldId id="374" r:id="rId11"/>
    <p:sldId id="375" r:id="rId12"/>
    <p:sldId id="376" r:id="rId13"/>
    <p:sldId id="377" r:id="rId14"/>
    <p:sldId id="378" r:id="rId15"/>
    <p:sldId id="379" r:id="rId16"/>
    <p:sldId id="380" r:id="rId17"/>
    <p:sldId id="381" r:id="rId18"/>
    <p:sldId id="348" r:id="rId19"/>
    <p:sldId id="280" r:id="rId20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9121" autoAdjust="0"/>
  </p:normalViewPr>
  <p:slideViewPr>
    <p:cSldViewPr>
      <p:cViewPr varScale="1">
        <p:scale>
          <a:sx n="86" d="100"/>
          <a:sy n="86" d="100"/>
        </p:scale>
        <p:origin x="-68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" Type="http://schemas.openxmlformats.org/officeDocument/2006/relationships/slide" Target="slides/slide1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theme" Target="theme/theme1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viewProps" Target="viewProp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25A2C0-97A5-43EE-8F52-F2D72281AF41}" type="datetimeFigureOut">
              <a:rPr lang="es-ES" smtClean="0"/>
              <a:t>07/01/2013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296483-B226-435A-A464-9553B67656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8737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898406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560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662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765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8675" name="Rectangle 3"/>
          <p:cNvSpPr>
            <a:spLocks noGrp="1" noChangeArrowheads="1"/>
          </p:cNvSpPr>
          <p:nvPr>
            <p:ph type="body" idx="1"/>
          </p:nvPr>
        </p:nvSpPr>
        <p:spPr>
          <a:ln w="9525"/>
        </p:spPr>
        <p:txBody>
          <a:bodyPr/>
          <a:lstStyle/>
          <a:p>
            <a:pPr>
              <a:defRPr/>
            </a:pPr>
            <a:endParaRPr lang="en-GB" dirty="0" smtClean="0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072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sz="1000" dirty="0" smtClean="0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174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lvl="1"/>
            <a:endParaRPr lang="en-GB" sz="1300" dirty="0" smtClean="0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8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38244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74117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91294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0595" name="Rectangle 3"/>
          <p:cNvSpPr>
            <a:spLocks noGrp="1" noChangeArrowheads="1"/>
          </p:cNvSpPr>
          <p:nvPr>
            <p:ph type="body" idx="1"/>
          </p:nvPr>
        </p:nvSpPr>
        <p:spPr>
          <a:ln w="9525"/>
        </p:spPr>
        <p:txBody>
          <a:bodyPr/>
          <a:lstStyle/>
          <a:p>
            <a:pPr marL="342900" indent="-342900">
              <a:spcBef>
                <a:spcPct val="20000"/>
              </a:spcBef>
              <a:defRPr/>
            </a:pPr>
            <a:endParaRPr lang="en-GB" kern="0" dirty="0" smtClean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048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150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253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sz="900" dirty="0" smtClean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355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457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395536" y="4149080"/>
            <a:ext cx="8208912" cy="1296144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4800" cap="all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endParaRPr lang="es-ES" sz="4800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021873-58E0-4EDA-8A4D-C7536C692D21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0303BB-CB7A-436B-8071-8D9A9713DDA2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1985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489" y="4406901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489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576D29-DC3D-470F-B8AC-0FE7EEBB267B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448E15-EBC7-4DB7-BD2F-E0C7BFD69F86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96976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56409D-069F-4719-9045-0FC1B5C7F8B5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B72315-323A-4FAE-9EB9-1CDA8FE11A96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1275754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012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012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378" y="1535113"/>
            <a:ext cx="4041422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378" y="2174875"/>
            <a:ext cx="4041422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6BE6D-415E-4EF1-AC9C-9A87AC7DD27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89B1B-DE11-4A4C-8042-CD37861870DA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19156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53B7E04-BCA7-4A50-8DA7-8FC472E1AFD5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A5E8A4-0F5C-452A-9D61-5197B5B5AB25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882401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1A53AC-47F6-4234-A0B7-9A7F91CEB43D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3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0C65D8-309A-434F-987C-E4C824B07CB3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482872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489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756" y="273051"/>
            <a:ext cx="5111044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1"/>
            <a:ext cx="3008489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676AE7-C2C8-44BA-AC85-F64844A7BA52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E082EA-E0C7-4E66-9CDA-B063E687FF3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120820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111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111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111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272ED6-27BC-46D9-B392-94D3B52E7B21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DD3396-783B-4623-B842-8EE0FE806923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332182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2DA083-BB84-412E-9945-E63FE647A667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63D231-E13A-420B-9B98-F525EFFA576E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249240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1" y="274639"/>
            <a:ext cx="6036733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6E6BFE-3FB8-4E41-AE59-908F7B45B21A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86F7BF4-7AAD-4829-A39F-B3E3F7F666D9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315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911" y="4826362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9442" y="675724"/>
            <a:ext cx="7125113" cy="924475"/>
          </a:xfrm>
          <a:prstGeom prst="rect">
            <a:avLst/>
          </a:prstGeo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38059" y="1807361"/>
            <a:ext cx="6474301" cy="4051437"/>
          </a:xfrm>
          <a:prstGeom prst="rect">
            <a:avLst/>
          </a:prstGeom>
        </p:spPr>
        <p:txBody>
          <a:bodyPr/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</a:p>
        </p:txBody>
      </p:sp>
      <p:sp>
        <p:nvSpPr>
          <p:cNvPr id="7" name="Title 1"/>
          <p:cNvSpPr txBox="1">
            <a:spLocks/>
          </p:cNvSpPr>
          <p:nvPr userDrawn="1"/>
        </p:nvSpPr>
        <p:spPr>
          <a:xfrm>
            <a:off x="1009442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B220F5-AF51-4B1C-A6BF-3BCB3BB72FF0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13B040-B8A3-4532-877A-6BDAFC815EAB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031511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F8E37F-C750-4D15-ACF0-87D7062E86EF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BA123D-C5E9-4899-88D7-4C1FD945C44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165611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47067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39733" y="1600200"/>
            <a:ext cx="4047067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457200" y="3938589"/>
            <a:ext cx="4047067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39733" y="3938589"/>
            <a:ext cx="4047067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95F2B3-D254-4AA5-BD6C-99D054784DE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070183-2AF1-420C-ADE2-13F13760017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309412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endParaRPr lang="en-GB" noProof="0" dirty="0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BCC2F1-3A07-40A2-98B4-ACD39BDA83D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E68D21-CC08-4C5F-8FB0-0FBD1DF7F0A5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4755819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914400" y="277813"/>
            <a:ext cx="7772400" cy="58531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3" name="Rectangle 9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10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11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5DB247-4791-4887-B2F4-B841C044AE65}" type="slidenum">
              <a:rPr lang="en-GB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GB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913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itle 1"/>
          <p:cNvSpPr txBox="1">
            <a:spLocks/>
          </p:cNvSpPr>
          <p:nvPr userDrawn="1"/>
        </p:nvSpPr>
        <p:spPr>
          <a:xfrm>
            <a:off x="1009442" y="4221088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2148" y="1809749"/>
            <a:ext cx="3148571" cy="405130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281" y="1809749"/>
            <a:ext cx="3077071" cy="4051302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43608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2148" y="1812927"/>
            <a:ext cx="3148571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2148" y="2389189"/>
            <a:ext cx="3148571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281" y="1812927"/>
            <a:ext cx="3149080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281" y="2389189"/>
            <a:ext cx="3077072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itle 1"/>
          <p:cNvSpPr txBox="1">
            <a:spLocks/>
          </p:cNvSpPr>
          <p:nvPr userDrawn="1"/>
        </p:nvSpPr>
        <p:spPr>
          <a:xfrm>
            <a:off x="983212" y="480856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2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6781" y="4830889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itle 1"/>
          <p:cNvSpPr txBox="1">
            <a:spLocks/>
          </p:cNvSpPr>
          <p:nvPr userDrawn="1"/>
        </p:nvSpPr>
        <p:spPr>
          <a:xfrm>
            <a:off x="993650" y="548680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8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52654" y="446087"/>
            <a:ext cx="4279869" cy="5414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9442" y="1631949"/>
            <a:ext cx="2660650" cy="422909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>
              <a:buNone/>
              <a:defRPr sz="1200">
                <a:latin typeface="Antique Olive" pitchFamily="34" charset="0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789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09442" y="404664"/>
            <a:ext cx="2698462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2D3B3B-3D1C-40BF-AEE0-44713500C184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FB3EF5-D0F2-465D-B08F-37FA4B8BE36D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8719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13" Type="http://schemas.openxmlformats.org/officeDocument/2006/relationships/slideLayout" Target="../slideLayouts/slideLayout21.xml"/><Relationship Id="rId18" Type="http://schemas.openxmlformats.org/officeDocument/2006/relationships/image" Target="../media/image3.jpeg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12" Type="http://schemas.openxmlformats.org/officeDocument/2006/relationships/slideLayout" Target="../slideLayouts/slideLayout20.xml"/><Relationship Id="rId17" Type="http://schemas.openxmlformats.org/officeDocument/2006/relationships/theme" Target="../theme/theme2.xml"/><Relationship Id="rId2" Type="http://schemas.openxmlformats.org/officeDocument/2006/relationships/slideLayout" Target="../slideLayouts/slideLayout10.xml"/><Relationship Id="rId16" Type="http://schemas.openxmlformats.org/officeDocument/2006/relationships/slideLayout" Target="../slideLayouts/slideLayout24.xml"/><Relationship Id="rId20" Type="http://schemas.openxmlformats.org/officeDocument/2006/relationships/image" Target="../media/image5.wmf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3.xml"/><Relationship Id="rId15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8.xml"/><Relationship Id="rId19" Type="http://schemas.openxmlformats.org/officeDocument/2006/relationships/image" Target="../media/image4.jpeg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Relationship Id="rId14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9000">
              <a:schemeClr val="bg2">
                <a:tint val="97000"/>
                <a:shade val="80000"/>
                <a:hueMod val="110000"/>
                <a:satMod val="120000"/>
              </a:schemeClr>
            </a:gs>
            <a:gs pos="100000">
              <a:schemeClr val="bg2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Oval 55"/>
          <p:cNvSpPr>
            <a:spLocks noChangeAspect="1"/>
          </p:cNvSpPr>
          <p:nvPr/>
        </p:nvSpPr>
        <p:spPr>
          <a:xfrm>
            <a:off x="-69625" y="4042576"/>
            <a:ext cx="1743945" cy="1909234"/>
          </a:xfrm>
          <a:custGeom>
            <a:avLst/>
            <a:gdLst/>
            <a:ahLst/>
            <a:cxnLst/>
            <a:rect l="l" t="t" r="r" b="b"/>
            <a:pathLst>
              <a:path w="1743945" h="1909234">
                <a:moveTo>
                  <a:pt x="789328" y="0"/>
                </a:moveTo>
                <a:cubicBezTo>
                  <a:pt x="1316548" y="0"/>
                  <a:pt x="1743945" y="427397"/>
                  <a:pt x="1743945" y="954617"/>
                </a:cubicBezTo>
                <a:cubicBezTo>
                  <a:pt x="1743945" y="1481837"/>
                  <a:pt x="1316548" y="1909234"/>
                  <a:pt x="789328" y="1909234"/>
                </a:cubicBezTo>
                <a:cubicBezTo>
                  <a:pt x="461080" y="1909234"/>
                  <a:pt x="171527" y="1743562"/>
                  <a:pt x="0" y="1491086"/>
                </a:cubicBezTo>
                <a:lnTo>
                  <a:pt x="0" y="418149"/>
                </a:lnTo>
                <a:cubicBezTo>
                  <a:pt x="171527" y="165673"/>
                  <a:pt x="461080" y="0"/>
                  <a:pt x="789328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3" name="Oval 52"/>
          <p:cNvSpPr>
            <a:spLocks noChangeAspect="1"/>
          </p:cNvSpPr>
          <p:nvPr/>
        </p:nvSpPr>
        <p:spPr>
          <a:xfrm>
            <a:off x="520638" y="1095310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2" name="Oval 51"/>
          <p:cNvSpPr>
            <a:spLocks noChangeAspect="1"/>
          </p:cNvSpPr>
          <p:nvPr/>
        </p:nvSpPr>
        <p:spPr>
          <a:xfrm>
            <a:off x="1878729" y="28293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0" name="Oval 129"/>
          <p:cNvSpPr>
            <a:spLocks noChangeAspect="1"/>
          </p:cNvSpPr>
          <p:nvPr/>
        </p:nvSpPr>
        <p:spPr>
          <a:xfrm>
            <a:off x="-46711" y="-61709"/>
            <a:ext cx="1449107" cy="1677064"/>
          </a:xfrm>
          <a:custGeom>
            <a:avLst/>
            <a:gdLst/>
            <a:ahLst/>
            <a:cxnLst/>
            <a:rect l="l" t="t" r="r" b="b"/>
            <a:pathLst>
              <a:path w="1449107" h="1677064">
                <a:moveTo>
                  <a:pt x="0" y="0"/>
                </a:moveTo>
                <a:lnTo>
                  <a:pt x="1112019" y="0"/>
                </a:lnTo>
                <a:cubicBezTo>
                  <a:pt x="1319407" y="171874"/>
                  <a:pt x="1449107" y="432014"/>
                  <a:pt x="1449107" y="722447"/>
                </a:cubicBezTo>
                <a:cubicBezTo>
                  <a:pt x="1449107" y="1249667"/>
                  <a:pt x="1021710" y="1677064"/>
                  <a:pt x="494490" y="1677064"/>
                </a:cubicBezTo>
                <a:cubicBezTo>
                  <a:pt x="313232" y="1677064"/>
                  <a:pt x="143772" y="1626546"/>
                  <a:pt x="0" y="1537872"/>
                </a:cubicBezTo>
                <a:close/>
              </a:path>
            </a:pathLst>
          </a:custGeom>
          <a:solidFill>
            <a:schemeClr val="tx2">
              <a:lumMod val="75000"/>
              <a:alpha val="14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1" name="Oval 130"/>
          <p:cNvSpPr>
            <a:spLocks noChangeAspect="1"/>
          </p:cNvSpPr>
          <p:nvPr/>
        </p:nvSpPr>
        <p:spPr>
          <a:xfrm>
            <a:off x="924113" y="-16162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2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2" name="Oval 131"/>
          <p:cNvSpPr>
            <a:spLocks noChangeAspect="1"/>
          </p:cNvSpPr>
          <p:nvPr/>
        </p:nvSpPr>
        <p:spPr>
          <a:xfrm>
            <a:off x="0" y="66073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3" name="Oval 132"/>
          <p:cNvSpPr>
            <a:spLocks noChangeAspect="1"/>
          </p:cNvSpPr>
          <p:nvPr/>
        </p:nvSpPr>
        <p:spPr>
          <a:xfrm>
            <a:off x="7497531" y="-61709"/>
            <a:ext cx="1694467" cy="1677064"/>
          </a:xfrm>
          <a:custGeom>
            <a:avLst/>
            <a:gdLst/>
            <a:ahLst/>
            <a:cxnLst/>
            <a:rect l="l" t="t" r="r" b="b"/>
            <a:pathLst>
              <a:path w="1694467" h="1677064">
                <a:moveTo>
                  <a:pt x="337088" y="0"/>
                </a:moveTo>
                <a:lnTo>
                  <a:pt x="1573463" y="0"/>
                </a:lnTo>
                <a:cubicBezTo>
                  <a:pt x="1618202" y="37449"/>
                  <a:pt x="1658454" y="79950"/>
                  <a:pt x="1694467" y="126010"/>
                </a:cubicBezTo>
                <a:lnTo>
                  <a:pt x="1694467" y="1318884"/>
                </a:lnTo>
                <a:cubicBezTo>
                  <a:pt x="1522840" y="1538397"/>
                  <a:pt x="1254922" y="1677064"/>
                  <a:pt x="954617" y="1677064"/>
                </a:cubicBezTo>
                <a:cubicBezTo>
                  <a:pt x="427397" y="1677064"/>
                  <a:pt x="0" y="1249667"/>
                  <a:pt x="0" y="722447"/>
                </a:cubicBezTo>
                <a:cubicBezTo>
                  <a:pt x="0" y="432014"/>
                  <a:pt x="129700" y="171874"/>
                  <a:pt x="337088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4" name="Oval 133"/>
          <p:cNvSpPr>
            <a:spLocks noChangeAspect="1"/>
          </p:cNvSpPr>
          <p:nvPr/>
        </p:nvSpPr>
        <p:spPr>
          <a:xfrm>
            <a:off x="6117502" y="-61708"/>
            <a:ext cx="1909234" cy="1705448"/>
          </a:xfrm>
          <a:custGeom>
            <a:avLst/>
            <a:gdLst/>
            <a:ahLst/>
            <a:cxnLst/>
            <a:rect l="l" t="t" r="r" b="b"/>
            <a:pathLst>
              <a:path w="1909234" h="1705448">
                <a:moveTo>
                  <a:pt x="371490" y="0"/>
                </a:moveTo>
                <a:lnTo>
                  <a:pt x="1537745" y="0"/>
                </a:lnTo>
                <a:cubicBezTo>
                  <a:pt x="1764760" y="171517"/>
                  <a:pt x="1909234" y="444302"/>
                  <a:pt x="1909234" y="750831"/>
                </a:cubicBezTo>
                <a:cubicBezTo>
                  <a:pt x="1909234" y="1278051"/>
                  <a:pt x="1481837" y="1705448"/>
                  <a:pt x="954617" y="1705448"/>
                </a:cubicBezTo>
                <a:cubicBezTo>
                  <a:pt x="427397" y="1705448"/>
                  <a:pt x="0" y="1278051"/>
                  <a:pt x="0" y="750831"/>
                </a:cubicBezTo>
                <a:cubicBezTo>
                  <a:pt x="0" y="444302"/>
                  <a:pt x="144474" y="171517"/>
                  <a:pt x="37149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5" name="Oval 134"/>
          <p:cNvSpPr>
            <a:spLocks noChangeAspect="1"/>
          </p:cNvSpPr>
          <p:nvPr/>
        </p:nvSpPr>
        <p:spPr>
          <a:xfrm>
            <a:off x="7494454" y="1095309"/>
            <a:ext cx="1697544" cy="1909234"/>
          </a:xfrm>
          <a:custGeom>
            <a:avLst/>
            <a:gdLst/>
            <a:ahLst/>
            <a:cxnLst/>
            <a:rect l="l" t="t" r="r" b="b"/>
            <a:pathLst>
              <a:path w="1697544" h="1909234">
                <a:moveTo>
                  <a:pt x="954617" y="0"/>
                </a:moveTo>
                <a:cubicBezTo>
                  <a:pt x="1256666" y="0"/>
                  <a:pt x="1525952" y="140283"/>
                  <a:pt x="1697544" y="361910"/>
                </a:cubicBezTo>
                <a:lnTo>
                  <a:pt x="1697544" y="1547324"/>
                </a:lnTo>
                <a:cubicBezTo>
                  <a:pt x="1525952" y="1768951"/>
                  <a:pt x="1256666" y="1909234"/>
                  <a:pt x="954617" y="1909234"/>
                </a:cubicBezTo>
                <a:cubicBezTo>
                  <a:pt x="427397" y="1909234"/>
                  <a:pt x="0" y="1481837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6" name="Oval 135"/>
          <p:cNvSpPr>
            <a:spLocks noChangeAspect="1"/>
          </p:cNvSpPr>
          <p:nvPr/>
        </p:nvSpPr>
        <p:spPr>
          <a:xfrm>
            <a:off x="8056674" y="5140346"/>
            <a:ext cx="1137194" cy="1759729"/>
          </a:xfrm>
          <a:custGeom>
            <a:avLst/>
            <a:gdLst/>
            <a:ahLst/>
            <a:cxnLst/>
            <a:rect l="l" t="t" r="r" b="b"/>
            <a:pathLst>
              <a:path w="1137194" h="1759729">
                <a:moveTo>
                  <a:pt x="954617" y="0"/>
                </a:moveTo>
                <a:cubicBezTo>
                  <a:pt x="1017088" y="0"/>
                  <a:pt x="1078157" y="6001"/>
                  <a:pt x="1137194" y="17897"/>
                </a:cubicBezTo>
                <a:lnTo>
                  <a:pt x="1137194" y="1759729"/>
                </a:lnTo>
                <a:lnTo>
                  <a:pt x="443151" y="1759729"/>
                </a:lnTo>
                <a:cubicBezTo>
                  <a:pt x="176544" y="1591075"/>
                  <a:pt x="0" y="1293463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7" name="Oval 136"/>
          <p:cNvSpPr>
            <a:spLocks noChangeAspect="1"/>
          </p:cNvSpPr>
          <p:nvPr/>
        </p:nvSpPr>
        <p:spPr>
          <a:xfrm>
            <a:off x="6661711" y="4362912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8" name="Oval 137"/>
          <p:cNvSpPr>
            <a:spLocks noChangeAspect="1"/>
          </p:cNvSpPr>
          <p:nvPr/>
        </p:nvSpPr>
        <p:spPr>
          <a:xfrm>
            <a:off x="-69625" y="4948766"/>
            <a:ext cx="1353860" cy="1909234"/>
          </a:xfrm>
          <a:custGeom>
            <a:avLst/>
            <a:gdLst/>
            <a:ahLst/>
            <a:cxnLst/>
            <a:rect l="l" t="t" r="r" b="b"/>
            <a:pathLst>
              <a:path w="1353860" h="1909234">
                <a:moveTo>
                  <a:pt x="399243" y="0"/>
                </a:moveTo>
                <a:cubicBezTo>
                  <a:pt x="926463" y="0"/>
                  <a:pt x="1353860" y="427397"/>
                  <a:pt x="1353860" y="954617"/>
                </a:cubicBezTo>
                <a:cubicBezTo>
                  <a:pt x="1353860" y="1481837"/>
                  <a:pt x="926463" y="1909234"/>
                  <a:pt x="399243" y="1909234"/>
                </a:cubicBezTo>
                <a:cubicBezTo>
                  <a:pt x="256544" y="1909234"/>
                  <a:pt x="121158" y="1877924"/>
                  <a:pt x="0" y="1820890"/>
                </a:cubicBezTo>
                <a:lnTo>
                  <a:pt x="0" y="88345"/>
                </a:lnTo>
                <a:cubicBezTo>
                  <a:pt x="121158" y="31311"/>
                  <a:pt x="256544" y="0"/>
                  <a:pt x="399243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0" name="Oval 139"/>
          <p:cNvSpPr>
            <a:spLocks noChangeAspect="1"/>
          </p:cNvSpPr>
          <p:nvPr/>
        </p:nvSpPr>
        <p:spPr>
          <a:xfrm>
            <a:off x="6117503" y="78398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1" name="Oval 140"/>
          <p:cNvSpPr>
            <a:spLocks noChangeAspect="1"/>
          </p:cNvSpPr>
          <p:nvPr/>
        </p:nvSpPr>
        <p:spPr>
          <a:xfrm>
            <a:off x="6459053" y="5140346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18" name="Oval 117"/>
          <p:cNvSpPr>
            <a:spLocks noChangeAspect="1"/>
          </p:cNvSpPr>
          <p:nvPr/>
        </p:nvSpPr>
        <p:spPr>
          <a:xfrm>
            <a:off x="8398204" y="597861"/>
            <a:ext cx="793794" cy="1252918"/>
          </a:xfrm>
          <a:custGeom>
            <a:avLst/>
            <a:gdLst/>
            <a:ahLst/>
            <a:cxnLst/>
            <a:rect l="l" t="t" r="r" b="b"/>
            <a:pathLst>
              <a:path w="793794" h="1252918">
                <a:moveTo>
                  <a:pt x="626459" y="0"/>
                </a:moveTo>
                <a:cubicBezTo>
                  <a:pt x="684682" y="0"/>
                  <a:pt x="741049" y="7943"/>
                  <a:pt x="793794" y="25480"/>
                </a:cubicBezTo>
                <a:lnTo>
                  <a:pt x="793794" y="1227438"/>
                </a:lnTo>
                <a:cubicBezTo>
                  <a:pt x="741049" y="1244975"/>
                  <a:pt x="684682" y="1252918"/>
                  <a:pt x="626459" y="1252918"/>
                </a:cubicBezTo>
                <a:cubicBezTo>
                  <a:pt x="280475" y="1252918"/>
                  <a:pt x="0" y="972443"/>
                  <a:pt x="0" y="626459"/>
                </a:cubicBezTo>
                <a:cubicBezTo>
                  <a:pt x="0" y="280475"/>
                  <a:pt x="280475" y="0"/>
                  <a:pt x="626459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Oval 119"/>
          <p:cNvSpPr>
            <a:spLocks noChangeAspect="1"/>
          </p:cNvSpPr>
          <p:nvPr/>
        </p:nvSpPr>
        <p:spPr>
          <a:xfrm>
            <a:off x="6872127" y="1450645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Oval 120"/>
          <p:cNvSpPr>
            <a:spLocks noChangeAspect="1"/>
          </p:cNvSpPr>
          <p:nvPr/>
        </p:nvSpPr>
        <p:spPr>
          <a:xfrm>
            <a:off x="7219068" y="2049927"/>
            <a:ext cx="1041276" cy="1041276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Oval 121"/>
          <p:cNvSpPr>
            <a:spLocks noChangeAspect="1"/>
          </p:cNvSpPr>
          <p:nvPr/>
        </p:nvSpPr>
        <p:spPr>
          <a:xfrm>
            <a:off x="7749416" y="2661634"/>
            <a:ext cx="721308" cy="721308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Oval 122"/>
          <p:cNvSpPr>
            <a:spLocks noChangeAspect="1"/>
          </p:cNvSpPr>
          <p:nvPr/>
        </p:nvSpPr>
        <p:spPr>
          <a:xfrm>
            <a:off x="685054" y="-100976"/>
            <a:ext cx="1193676" cy="697815"/>
          </a:xfrm>
          <a:custGeom>
            <a:avLst/>
            <a:gdLst/>
            <a:ahLst/>
            <a:cxnLst/>
            <a:rect l="l" t="t" r="r" b="b"/>
            <a:pathLst>
              <a:path w="1193676" h="697815">
                <a:moveTo>
                  <a:pt x="10179" y="0"/>
                </a:moveTo>
                <a:lnTo>
                  <a:pt x="1183497" y="0"/>
                </a:lnTo>
                <a:cubicBezTo>
                  <a:pt x="1190746" y="32633"/>
                  <a:pt x="1193676" y="66463"/>
                  <a:pt x="1193676" y="100977"/>
                </a:cubicBezTo>
                <a:cubicBezTo>
                  <a:pt x="1193676" y="430602"/>
                  <a:pt x="926463" y="697815"/>
                  <a:pt x="596838" y="697815"/>
                </a:cubicBezTo>
                <a:cubicBezTo>
                  <a:pt x="267213" y="697815"/>
                  <a:pt x="0" y="430602"/>
                  <a:pt x="0" y="100977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>
            <a:spLocks noChangeAspect="1"/>
          </p:cNvSpPr>
          <p:nvPr/>
        </p:nvSpPr>
        <p:spPr>
          <a:xfrm>
            <a:off x="1502638" y="-100976"/>
            <a:ext cx="1029028" cy="459889"/>
          </a:xfrm>
          <a:custGeom>
            <a:avLst/>
            <a:gdLst/>
            <a:ahLst/>
            <a:cxnLst/>
            <a:rect l="l" t="t" r="r" b="b"/>
            <a:pathLst>
              <a:path w="1029028" h="459889">
                <a:moveTo>
                  <a:pt x="0" y="0"/>
                </a:moveTo>
                <a:lnTo>
                  <a:pt x="1029028" y="0"/>
                </a:lnTo>
                <a:cubicBezTo>
                  <a:pt x="1001386" y="259074"/>
                  <a:pt x="781401" y="459889"/>
                  <a:pt x="514514" y="459889"/>
                </a:cubicBezTo>
                <a:cubicBezTo>
                  <a:pt x="247627" y="459889"/>
                  <a:pt x="27642" y="259074"/>
                  <a:pt x="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Oval 124"/>
          <p:cNvSpPr>
            <a:spLocks noChangeAspect="1"/>
          </p:cNvSpPr>
          <p:nvPr/>
        </p:nvSpPr>
        <p:spPr>
          <a:xfrm>
            <a:off x="-69624" y="-100976"/>
            <a:ext cx="590263" cy="612289"/>
          </a:xfrm>
          <a:custGeom>
            <a:avLst/>
            <a:gdLst/>
            <a:ahLst/>
            <a:cxnLst/>
            <a:rect l="l" t="t" r="r" b="b"/>
            <a:pathLst>
              <a:path w="590263" h="612289">
                <a:moveTo>
                  <a:pt x="0" y="0"/>
                </a:moveTo>
                <a:lnTo>
                  <a:pt x="581024" y="0"/>
                </a:lnTo>
                <a:cubicBezTo>
                  <a:pt x="587493" y="29611"/>
                  <a:pt x="590263" y="60308"/>
                  <a:pt x="590263" y="91651"/>
                </a:cubicBezTo>
                <a:cubicBezTo>
                  <a:pt x="590263" y="379191"/>
                  <a:pt x="357165" y="612289"/>
                  <a:pt x="69625" y="612289"/>
                </a:cubicBezTo>
                <a:lnTo>
                  <a:pt x="0" y="605270"/>
                </a:ln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Oval 125"/>
          <p:cNvSpPr>
            <a:spLocks noChangeAspect="1"/>
          </p:cNvSpPr>
          <p:nvPr/>
        </p:nvSpPr>
        <p:spPr>
          <a:xfrm>
            <a:off x="277432" y="4321783"/>
            <a:ext cx="1396887" cy="1396887"/>
          </a:xfrm>
          <a:prstGeom prst="ellipse">
            <a:avLst/>
          </a:pr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Oval 126"/>
          <p:cNvSpPr>
            <a:spLocks noChangeAspect="1"/>
          </p:cNvSpPr>
          <p:nvPr/>
        </p:nvSpPr>
        <p:spPr>
          <a:xfrm>
            <a:off x="5792131" y="6489965"/>
            <a:ext cx="1115939" cy="443769"/>
          </a:xfrm>
          <a:custGeom>
            <a:avLst/>
            <a:gdLst/>
            <a:ahLst/>
            <a:cxnLst/>
            <a:rect l="l" t="t" r="r" b="b"/>
            <a:pathLst>
              <a:path w="1115939" h="443769">
                <a:moveTo>
                  <a:pt x="557969" y="0"/>
                </a:moveTo>
                <a:cubicBezTo>
                  <a:pt x="830120" y="0"/>
                  <a:pt x="1058049" y="189335"/>
                  <a:pt x="1115939" y="443769"/>
                </a:cubicBezTo>
                <a:lnTo>
                  <a:pt x="0" y="443769"/>
                </a:lnTo>
                <a:cubicBezTo>
                  <a:pt x="57889" y="189335"/>
                  <a:pt x="285818" y="0"/>
                  <a:pt x="55796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Oval 127"/>
          <p:cNvSpPr>
            <a:spLocks noChangeAspect="1"/>
          </p:cNvSpPr>
          <p:nvPr/>
        </p:nvSpPr>
        <p:spPr>
          <a:xfrm>
            <a:off x="6127999" y="6408840"/>
            <a:ext cx="1237019" cy="524894"/>
          </a:xfrm>
          <a:custGeom>
            <a:avLst/>
            <a:gdLst/>
            <a:ahLst/>
            <a:cxnLst/>
            <a:rect l="l" t="t" r="r" b="b"/>
            <a:pathLst>
              <a:path w="1237019" h="524894">
                <a:moveTo>
                  <a:pt x="618509" y="0"/>
                </a:moveTo>
                <a:cubicBezTo>
                  <a:pt x="930325" y="0"/>
                  <a:pt x="1189147" y="226891"/>
                  <a:pt x="1237019" y="524894"/>
                </a:cubicBezTo>
                <a:lnTo>
                  <a:pt x="0" y="524894"/>
                </a:lnTo>
                <a:cubicBezTo>
                  <a:pt x="47872" y="226891"/>
                  <a:pt x="306694" y="0"/>
                  <a:pt x="61850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Oval 128"/>
          <p:cNvSpPr>
            <a:spLocks noChangeAspect="1"/>
          </p:cNvSpPr>
          <p:nvPr/>
        </p:nvSpPr>
        <p:spPr>
          <a:xfrm>
            <a:off x="7577655" y="6408841"/>
            <a:ext cx="1211408" cy="524893"/>
          </a:xfrm>
          <a:custGeom>
            <a:avLst/>
            <a:gdLst/>
            <a:ahLst/>
            <a:cxnLst/>
            <a:rect l="l" t="t" r="r" b="b"/>
            <a:pathLst>
              <a:path w="1211408" h="524893">
                <a:moveTo>
                  <a:pt x="605704" y="0"/>
                </a:moveTo>
                <a:cubicBezTo>
                  <a:pt x="914574" y="0"/>
                  <a:pt x="1170243" y="227782"/>
                  <a:pt x="1211408" y="524893"/>
                </a:cubicBezTo>
                <a:lnTo>
                  <a:pt x="0" y="524893"/>
                </a:lnTo>
                <a:cubicBezTo>
                  <a:pt x="41165" y="227782"/>
                  <a:pt x="296834" y="0"/>
                  <a:pt x="605704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Oval 96"/>
          <p:cNvSpPr>
            <a:spLocks noChangeAspect="1"/>
          </p:cNvSpPr>
          <p:nvPr/>
        </p:nvSpPr>
        <p:spPr>
          <a:xfrm>
            <a:off x="11073" y="4941986"/>
            <a:ext cx="611230" cy="61123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Oval 97"/>
          <p:cNvSpPr>
            <a:spLocks noChangeAspect="1"/>
          </p:cNvSpPr>
          <p:nvPr/>
        </p:nvSpPr>
        <p:spPr>
          <a:xfrm>
            <a:off x="-69625" y="6172569"/>
            <a:ext cx="778097" cy="750322"/>
          </a:xfrm>
          <a:custGeom>
            <a:avLst/>
            <a:gdLst/>
            <a:ahLst/>
            <a:cxnLst/>
            <a:rect l="l" t="t" r="r" b="b"/>
            <a:pathLst>
              <a:path w="778097" h="750322">
                <a:moveTo>
                  <a:pt x="261411" y="0"/>
                </a:moveTo>
                <a:cubicBezTo>
                  <a:pt x="546769" y="0"/>
                  <a:pt x="778097" y="231328"/>
                  <a:pt x="778097" y="516686"/>
                </a:cubicBezTo>
                <a:cubicBezTo>
                  <a:pt x="778097" y="601179"/>
                  <a:pt x="757816" y="680934"/>
                  <a:pt x="719843" y="750322"/>
                </a:cubicBezTo>
                <a:lnTo>
                  <a:pt x="0" y="750322"/>
                </a:lnTo>
                <a:lnTo>
                  <a:pt x="0" y="73330"/>
                </a:lnTo>
                <a:cubicBezTo>
                  <a:pt x="75863" y="26083"/>
                  <a:pt x="165591" y="0"/>
                  <a:pt x="26141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Oval 98"/>
          <p:cNvSpPr>
            <a:spLocks noChangeAspect="1"/>
          </p:cNvSpPr>
          <p:nvPr/>
        </p:nvSpPr>
        <p:spPr>
          <a:xfrm>
            <a:off x="-69625" y="5158575"/>
            <a:ext cx="563524" cy="897560"/>
          </a:xfrm>
          <a:custGeom>
            <a:avLst/>
            <a:gdLst/>
            <a:ahLst/>
            <a:cxnLst/>
            <a:rect l="l" t="t" r="r" b="b"/>
            <a:pathLst>
              <a:path w="563524" h="897560">
                <a:moveTo>
                  <a:pt x="114744" y="0"/>
                </a:moveTo>
                <a:cubicBezTo>
                  <a:pt x="362598" y="0"/>
                  <a:pt x="563524" y="200926"/>
                  <a:pt x="563524" y="448780"/>
                </a:cubicBezTo>
                <a:cubicBezTo>
                  <a:pt x="563524" y="696634"/>
                  <a:pt x="362598" y="897560"/>
                  <a:pt x="114744" y="897560"/>
                </a:cubicBezTo>
                <a:cubicBezTo>
                  <a:pt x="74918" y="897560"/>
                  <a:pt x="36304" y="892373"/>
                  <a:pt x="0" y="880900"/>
                </a:cubicBezTo>
                <a:lnTo>
                  <a:pt x="0" y="16661"/>
                </a:lnTo>
                <a:cubicBezTo>
                  <a:pt x="36304" y="5188"/>
                  <a:pt x="74918" y="0"/>
                  <a:pt x="11474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Oval 99"/>
          <p:cNvSpPr>
            <a:spLocks noChangeAspect="1"/>
          </p:cNvSpPr>
          <p:nvPr/>
        </p:nvSpPr>
        <p:spPr>
          <a:xfrm>
            <a:off x="-25758" y="482386"/>
            <a:ext cx="598416" cy="905704"/>
          </a:xfrm>
          <a:custGeom>
            <a:avLst/>
            <a:gdLst/>
            <a:ahLst/>
            <a:cxnLst/>
            <a:rect l="l" t="t" r="r" b="b"/>
            <a:pathLst>
              <a:path w="598416" h="905704">
                <a:moveTo>
                  <a:pt x="145564" y="0"/>
                </a:moveTo>
                <a:cubicBezTo>
                  <a:pt x="395667" y="0"/>
                  <a:pt x="598416" y="202749"/>
                  <a:pt x="598416" y="452852"/>
                </a:cubicBezTo>
                <a:cubicBezTo>
                  <a:pt x="598416" y="702955"/>
                  <a:pt x="395667" y="905704"/>
                  <a:pt x="145564" y="905704"/>
                </a:cubicBezTo>
                <a:cubicBezTo>
                  <a:pt x="94398" y="905704"/>
                  <a:pt x="45214" y="897218"/>
                  <a:pt x="0" y="879648"/>
                </a:cubicBezTo>
                <a:lnTo>
                  <a:pt x="0" y="26056"/>
                </a:lnTo>
                <a:cubicBezTo>
                  <a:pt x="45214" y="8486"/>
                  <a:pt x="94398" y="0"/>
                  <a:pt x="14556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>
            <a:spLocks noChangeAspect="1"/>
          </p:cNvSpPr>
          <p:nvPr/>
        </p:nvSpPr>
        <p:spPr>
          <a:xfrm>
            <a:off x="474208" y="836793"/>
            <a:ext cx="910817" cy="91081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>
            <a:spLocks noChangeAspect="1"/>
          </p:cNvSpPr>
          <p:nvPr/>
        </p:nvSpPr>
        <p:spPr>
          <a:xfrm>
            <a:off x="319223" y="1452260"/>
            <a:ext cx="772993" cy="772993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Oval 102"/>
          <p:cNvSpPr>
            <a:spLocks noChangeAspect="1"/>
          </p:cNvSpPr>
          <p:nvPr/>
        </p:nvSpPr>
        <p:spPr>
          <a:xfrm>
            <a:off x="371257" y="1886983"/>
            <a:ext cx="610366" cy="610366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>
            <a:spLocks noChangeAspect="1"/>
          </p:cNvSpPr>
          <p:nvPr/>
        </p:nvSpPr>
        <p:spPr>
          <a:xfrm>
            <a:off x="154676" y="1919682"/>
            <a:ext cx="521764" cy="52176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>
            <a:spLocks noChangeAspect="1"/>
          </p:cNvSpPr>
          <p:nvPr/>
        </p:nvSpPr>
        <p:spPr>
          <a:xfrm>
            <a:off x="7302517" y="-61709"/>
            <a:ext cx="910818" cy="750833"/>
          </a:xfrm>
          <a:custGeom>
            <a:avLst/>
            <a:gdLst/>
            <a:ahLst/>
            <a:cxnLst/>
            <a:rect l="l" t="t" r="r" b="b"/>
            <a:pathLst>
              <a:path w="910818" h="750833">
                <a:moveTo>
                  <a:pt x="111441" y="0"/>
                </a:moveTo>
                <a:lnTo>
                  <a:pt x="799378" y="0"/>
                </a:lnTo>
                <a:cubicBezTo>
                  <a:pt x="869408" y="78400"/>
                  <a:pt x="910818" y="182076"/>
                  <a:pt x="910818" y="295424"/>
                </a:cubicBezTo>
                <a:cubicBezTo>
                  <a:pt x="910818" y="546939"/>
                  <a:pt x="706924" y="750833"/>
                  <a:pt x="455409" y="750833"/>
                </a:cubicBezTo>
                <a:cubicBezTo>
                  <a:pt x="203894" y="750833"/>
                  <a:pt x="0" y="546939"/>
                  <a:pt x="0" y="295424"/>
                </a:cubicBezTo>
                <a:cubicBezTo>
                  <a:pt x="0" y="182076"/>
                  <a:pt x="41410" y="78400"/>
                  <a:pt x="11144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>
            <a:spLocks noChangeAspect="1"/>
          </p:cNvSpPr>
          <p:nvPr/>
        </p:nvSpPr>
        <p:spPr>
          <a:xfrm>
            <a:off x="8718124" y="-61709"/>
            <a:ext cx="473874" cy="613011"/>
          </a:xfrm>
          <a:custGeom>
            <a:avLst/>
            <a:gdLst/>
            <a:ahLst/>
            <a:cxnLst/>
            <a:rect l="l" t="t" r="r" b="b"/>
            <a:pathLst>
              <a:path w="473874" h="613011">
                <a:moveTo>
                  <a:pt x="29684" y="0"/>
                </a:moveTo>
                <a:lnTo>
                  <a:pt x="473874" y="0"/>
                </a:lnTo>
                <a:lnTo>
                  <a:pt x="473874" y="611150"/>
                </a:lnTo>
                <a:cubicBezTo>
                  <a:pt x="467789" y="612887"/>
                  <a:pt x="461614" y="613011"/>
                  <a:pt x="455409" y="613011"/>
                </a:cubicBezTo>
                <a:cubicBezTo>
                  <a:pt x="203894" y="613011"/>
                  <a:pt x="0" y="409117"/>
                  <a:pt x="0" y="157602"/>
                </a:cubicBezTo>
                <a:cubicBezTo>
                  <a:pt x="0" y="101995"/>
                  <a:pt x="9966" y="48716"/>
                  <a:pt x="2968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Oval 106"/>
          <p:cNvSpPr>
            <a:spLocks noChangeAspect="1"/>
          </p:cNvSpPr>
          <p:nvPr/>
        </p:nvSpPr>
        <p:spPr>
          <a:xfrm>
            <a:off x="7748238" y="282933"/>
            <a:ext cx="1128521" cy="1128521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Oval 107"/>
          <p:cNvSpPr>
            <a:spLocks noChangeAspect="1"/>
          </p:cNvSpPr>
          <p:nvPr/>
        </p:nvSpPr>
        <p:spPr>
          <a:xfrm>
            <a:off x="8914718" y="749603"/>
            <a:ext cx="277280" cy="907992"/>
          </a:xfrm>
          <a:custGeom>
            <a:avLst/>
            <a:gdLst/>
            <a:ahLst/>
            <a:cxnLst/>
            <a:rect l="l" t="t" r="r" b="b"/>
            <a:pathLst>
              <a:path w="277280" h="907992">
                <a:moveTo>
                  <a:pt x="277280" y="0"/>
                </a:moveTo>
                <a:lnTo>
                  <a:pt x="277280" y="907992"/>
                </a:lnTo>
                <a:cubicBezTo>
                  <a:pt x="112021" y="824131"/>
                  <a:pt x="0" y="652146"/>
                  <a:pt x="0" y="453996"/>
                </a:cubicBezTo>
                <a:cubicBezTo>
                  <a:pt x="0" y="255847"/>
                  <a:pt x="112021" y="83861"/>
                  <a:pt x="277280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Oval 108"/>
          <p:cNvSpPr>
            <a:spLocks noChangeAspect="1"/>
          </p:cNvSpPr>
          <p:nvPr/>
        </p:nvSpPr>
        <p:spPr>
          <a:xfrm>
            <a:off x="7590871" y="728498"/>
            <a:ext cx="969734" cy="9697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Oval 109"/>
          <p:cNvSpPr>
            <a:spLocks noChangeAspect="1"/>
          </p:cNvSpPr>
          <p:nvPr/>
        </p:nvSpPr>
        <p:spPr>
          <a:xfrm>
            <a:off x="7470041" y="1326476"/>
            <a:ext cx="608190" cy="60819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Oval 110"/>
          <p:cNvSpPr>
            <a:spLocks noChangeAspect="1"/>
          </p:cNvSpPr>
          <p:nvPr/>
        </p:nvSpPr>
        <p:spPr>
          <a:xfrm>
            <a:off x="7629941" y="5611427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Oval 111"/>
          <p:cNvSpPr>
            <a:spLocks noChangeAspect="1"/>
          </p:cNvSpPr>
          <p:nvPr/>
        </p:nvSpPr>
        <p:spPr>
          <a:xfrm>
            <a:off x="6972882" y="5242254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Oval 112"/>
          <p:cNvSpPr>
            <a:spLocks noChangeAspect="1"/>
          </p:cNvSpPr>
          <p:nvPr/>
        </p:nvSpPr>
        <p:spPr>
          <a:xfrm>
            <a:off x="7494454" y="4928166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Oval 113"/>
          <p:cNvSpPr>
            <a:spLocks noChangeAspect="1"/>
          </p:cNvSpPr>
          <p:nvPr/>
        </p:nvSpPr>
        <p:spPr>
          <a:xfrm>
            <a:off x="8229034" y="5666511"/>
            <a:ext cx="605634" cy="6056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Oval 114"/>
          <p:cNvSpPr>
            <a:spLocks noChangeAspect="1"/>
          </p:cNvSpPr>
          <p:nvPr/>
        </p:nvSpPr>
        <p:spPr>
          <a:xfrm>
            <a:off x="8078231" y="4097842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Oval 115"/>
          <p:cNvSpPr>
            <a:spLocks noChangeAspect="1"/>
          </p:cNvSpPr>
          <p:nvPr/>
        </p:nvSpPr>
        <p:spPr>
          <a:xfrm>
            <a:off x="8411816" y="5057878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Oval 116"/>
          <p:cNvSpPr>
            <a:spLocks noChangeAspect="1"/>
          </p:cNvSpPr>
          <p:nvPr/>
        </p:nvSpPr>
        <p:spPr>
          <a:xfrm>
            <a:off x="8688590" y="4790335"/>
            <a:ext cx="503408" cy="553550"/>
          </a:xfrm>
          <a:custGeom>
            <a:avLst/>
            <a:gdLst/>
            <a:ahLst/>
            <a:cxnLst/>
            <a:rect l="l" t="t" r="r" b="b"/>
            <a:pathLst>
              <a:path w="503408" h="553550">
                <a:moveTo>
                  <a:pt x="276775" y="0"/>
                </a:moveTo>
                <a:cubicBezTo>
                  <a:pt x="370698" y="0"/>
                  <a:pt x="453694" y="46784"/>
                  <a:pt x="503408" y="118545"/>
                </a:cubicBezTo>
                <a:lnTo>
                  <a:pt x="503408" y="435005"/>
                </a:lnTo>
                <a:cubicBezTo>
                  <a:pt x="453694" y="506767"/>
                  <a:pt x="370698" y="553550"/>
                  <a:pt x="276775" y="553550"/>
                </a:cubicBezTo>
                <a:cubicBezTo>
                  <a:pt x="123916" y="553550"/>
                  <a:pt x="0" y="429634"/>
                  <a:pt x="0" y="276775"/>
                </a:cubicBezTo>
                <a:cubicBezTo>
                  <a:pt x="0" y="123916"/>
                  <a:pt x="123916" y="0"/>
                  <a:pt x="276775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/>
          <p:cNvSpPr>
            <a:spLocks noChangeAspect="1"/>
          </p:cNvSpPr>
          <p:nvPr/>
        </p:nvSpPr>
        <p:spPr>
          <a:xfrm>
            <a:off x="8570944" y="3382942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/>
          <p:cNvSpPr>
            <a:spLocks noChangeAspect="1"/>
          </p:cNvSpPr>
          <p:nvPr/>
        </p:nvSpPr>
        <p:spPr>
          <a:xfrm>
            <a:off x="8398204" y="35360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Oval 58"/>
          <p:cNvSpPr>
            <a:spLocks noChangeAspect="1"/>
          </p:cNvSpPr>
          <p:nvPr/>
        </p:nvSpPr>
        <p:spPr>
          <a:xfrm>
            <a:off x="8608408" y="36884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Oval 59"/>
          <p:cNvSpPr>
            <a:spLocks noChangeAspect="1"/>
          </p:cNvSpPr>
          <p:nvPr/>
        </p:nvSpPr>
        <p:spPr>
          <a:xfrm>
            <a:off x="154676" y="2698928"/>
            <a:ext cx="467627" cy="46762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>
            <a:spLocks noChangeAspect="1"/>
          </p:cNvSpPr>
          <p:nvPr/>
        </p:nvSpPr>
        <p:spPr>
          <a:xfrm>
            <a:off x="474208" y="3166555"/>
            <a:ext cx="458770" cy="45877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Oval 61"/>
          <p:cNvSpPr>
            <a:spLocks noChangeAspect="1"/>
          </p:cNvSpPr>
          <p:nvPr/>
        </p:nvSpPr>
        <p:spPr>
          <a:xfrm>
            <a:off x="270258" y="3382942"/>
            <a:ext cx="352045" cy="3520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>
            <a:spLocks noChangeAspect="1"/>
          </p:cNvSpPr>
          <p:nvPr/>
        </p:nvSpPr>
        <p:spPr>
          <a:xfrm>
            <a:off x="-86601" y="2581479"/>
            <a:ext cx="1360441" cy="1909234"/>
          </a:xfrm>
          <a:custGeom>
            <a:avLst/>
            <a:gdLst/>
            <a:ahLst/>
            <a:cxnLst/>
            <a:rect l="l" t="t" r="r" b="b"/>
            <a:pathLst>
              <a:path w="1360441" h="1909234">
                <a:moveTo>
                  <a:pt x="405824" y="0"/>
                </a:moveTo>
                <a:cubicBezTo>
                  <a:pt x="933044" y="0"/>
                  <a:pt x="1360441" y="427397"/>
                  <a:pt x="1360441" y="954617"/>
                </a:cubicBezTo>
                <a:cubicBezTo>
                  <a:pt x="1360441" y="1481837"/>
                  <a:pt x="933044" y="1909234"/>
                  <a:pt x="405824" y="1909234"/>
                </a:cubicBezTo>
                <a:cubicBezTo>
                  <a:pt x="260527" y="1909234"/>
                  <a:pt x="122812" y="1876773"/>
                  <a:pt x="0" y="1817719"/>
                </a:cubicBezTo>
                <a:lnTo>
                  <a:pt x="0" y="91515"/>
                </a:lnTo>
                <a:cubicBezTo>
                  <a:pt x="122812" y="32461"/>
                  <a:pt x="260527" y="0"/>
                  <a:pt x="405824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64" name="Oval 63"/>
          <p:cNvSpPr>
            <a:spLocks noChangeAspect="1"/>
          </p:cNvSpPr>
          <p:nvPr/>
        </p:nvSpPr>
        <p:spPr>
          <a:xfrm>
            <a:off x="6173123" y="2395416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itle 1"/>
          <p:cNvSpPr txBox="1">
            <a:spLocks/>
          </p:cNvSpPr>
          <p:nvPr userDrawn="1"/>
        </p:nvSpPr>
        <p:spPr>
          <a:xfrm>
            <a:off x="1039484" y="4149080"/>
            <a:ext cx="7117180" cy="1288535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5400" cap="all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r>
              <a:rPr lang="en-US" sz="5400" cap="all" baseline="0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 </a:t>
            </a:r>
            <a:endParaRPr lang="en-US" sz="4800" cap="all" noProof="0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</p:sldLayoutIdLst>
  <p:timing>
    <p:tnLst>
      <p:par>
        <p:cTn id="1" dur="indefinite" restart="never" nodeType="tmRoot"/>
      </p:par>
    </p:tnLst>
  </p:timing>
  <p:txStyles>
    <p:titleStyle>
      <a:lvl1pPr algn="l" defTabSz="457200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Trebuchet M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330" name="Rectangle 2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8CF08C2-A99C-4E56-93BB-9E683A0985B3}" type="datetime1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483331" name="Rectangle 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GB">
              <a:solidFill>
                <a:srgbClr val="000000"/>
              </a:solidFill>
            </a:endParaRPr>
          </a:p>
        </p:txBody>
      </p:sp>
      <p:pic>
        <p:nvPicPr>
          <p:cNvPr id="56324" name="Picture 4" descr="Page header wide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1"/>
            <a:ext cx="9144000" cy="1465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6325" name="Picture 5" descr="Corner graphic"/>
          <p:cNvPicPr>
            <a:picLocks noChangeAspect="1" noChangeArrowheads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532989" y="6391275"/>
            <a:ext cx="613833" cy="46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3334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46900" y="6453188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600">
                <a:solidFill>
                  <a:schemeClr val="bg1"/>
                </a:solidFill>
                <a:latin typeface="Arial Black" pitchFamily="34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907DD276-FC31-4BA9-ABD0-6750AD0DA2D0}" type="slidenum">
              <a:rPr lang="en-US">
                <a:solidFill>
                  <a:srgbClr val="FFFFFF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  <p:pic>
        <p:nvPicPr>
          <p:cNvPr id="56327" name="Picture 7"/>
          <p:cNvPicPr>
            <a:picLocks noChangeAspect="1" noChangeArrowheads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5715000"/>
            <a:ext cx="674511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75203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  <p:sldLayoutId id="2147483685" r:id="rId2"/>
    <p:sldLayoutId id="2147483686" r:id="rId3"/>
    <p:sldLayoutId id="2147483687" r:id="rId4"/>
    <p:sldLayoutId id="2147483688" r:id="rId5"/>
    <p:sldLayoutId id="2147483689" r:id="rId6"/>
    <p:sldLayoutId id="2147483690" r:id="rId7"/>
    <p:sldLayoutId id="2147483691" r:id="rId8"/>
    <p:sldLayoutId id="2147483692" r:id="rId9"/>
    <p:sldLayoutId id="2147483693" r:id="rId10"/>
    <p:sldLayoutId id="2147483694" r:id="rId11"/>
    <p:sldLayoutId id="2147483695" r:id="rId12"/>
    <p:sldLayoutId id="2147483696" r:id="rId13"/>
    <p:sldLayoutId id="2147483697" r:id="rId14"/>
    <p:sldLayoutId id="2147483698" r:id="rId15"/>
    <p:sldLayoutId id="2147483699" r:id="rId16"/>
  </p:sldLayoutIdLst>
  <p:timing>
    <p:tnLst>
      <p:par>
        <p:cTn id="1" dur="indefinite" restart="never" nodeType="tmRoot"/>
      </p:par>
    </p:tnLst>
  </p:timing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5918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492896"/>
            <a:ext cx="7304360" cy="320608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US" sz="2800" b="1" dirty="0" smtClean="0"/>
              <a:t>Collaborate with other support services</a:t>
            </a:r>
          </a:p>
          <a:p>
            <a:pPr marL="609600" indent="-609600">
              <a:buFontTx/>
              <a:buNone/>
            </a:pPr>
            <a:endParaRPr lang="en-US" sz="1600" b="1" dirty="0" smtClean="0"/>
          </a:p>
          <a:p>
            <a:pPr marL="609600" indent="-609600">
              <a:buFontTx/>
              <a:buNone/>
            </a:pPr>
            <a:r>
              <a:rPr lang="en-US" sz="2800" dirty="0" smtClean="0"/>
              <a:t>	Prevention activities and response strategies</a:t>
            </a:r>
          </a:p>
        </p:txBody>
      </p:sp>
      <p:sp>
        <p:nvSpPr>
          <p:cNvPr id="9220" name="Text Box 4"/>
          <p:cNvSpPr txBox="1">
            <a:spLocks noChangeArrowheads="1"/>
          </p:cNvSpPr>
          <p:nvPr/>
        </p:nvSpPr>
        <p:spPr bwMode="auto">
          <a:xfrm>
            <a:off x="7092280" y="704890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6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0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2804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287413"/>
            <a:ext cx="7439827" cy="452596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Ensure the confidentiality and privacy of trafficked persons and their families</a:t>
            </a:r>
          </a:p>
          <a:p>
            <a:pPr marL="609600" indent="-609600">
              <a:buFontTx/>
              <a:buNone/>
            </a:pPr>
            <a:endParaRPr lang="en-GB" sz="1400" dirty="0" smtClean="0"/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Put measures into place to make sure all communications with and about trafficked persons are dealt with confidentiall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Ensure that each trafficked person is assured that his or her privacy is respected</a:t>
            </a:r>
          </a:p>
        </p:txBody>
      </p:sp>
      <p:sp>
        <p:nvSpPr>
          <p:cNvPr id="10244" name="Text Box 4"/>
          <p:cNvSpPr txBox="1">
            <a:spLocks noChangeArrowheads="1"/>
          </p:cNvSpPr>
          <p:nvPr/>
        </p:nvSpPr>
        <p:spPr bwMode="auto">
          <a:xfrm>
            <a:off x="7126336" y="692696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7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1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4815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287413"/>
            <a:ext cx="7609160" cy="452596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Provide information in a way that each person can understand</a:t>
            </a:r>
          </a:p>
          <a:p>
            <a:pPr marL="609600" indent="-609600">
              <a:buFontTx/>
              <a:buNone/>
            </a:pPr>
            <a:endParaRPr lang="en-GB" sz="1200" b="1" dirty="0" smtClean="0"/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Be clear when communicating care plans, purposes and procedures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Take the time necessary to ensure that the individual completely understands 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Give the patient opportunities to ask questions</a:t>
            </a:r>
          </a:p>
        </p:txBody>
      </p:sp>
      <p:sp>
        <p:nvSpPr>
          <p:cNvPr id="11268" name="Text Box 4"/>
          <p:cNvSpPr txBox="1">
            <a:spLocks noChangeArrowheads="1"/>
          </p:cNvSpPr>
          <p:nvPr/>
        </p:nvSpPr>
        <p:spPr bwMode="auto">
          <a:xfrm>
            <a:off x="7236296" y="704890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8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2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5953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185333" y="2438401"/>
            <a:ext cx="7755467" cy="376396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Obtain voluntary, informed consent</a:t>
            </a:r>
          </a:p>
          <a:p>
            <a:pPr marL="609600" indent="-609600">
              <a:buFontTx/>
              <a:buNone/>
            </a:pPr>
            <a:endParaRPr lang="en-GB" sz="1600" dirty="0" smtClean="0"/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Transfer of patient information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US" sz="2400" dirty="0" smtClean="0"/>
              <a:t>Diagnosing and treating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US" sz="2400" dirty="0" smtClean="0"/>
              <a:t>Necessary information</a:t>
            </a:r>
          </a:p>
          <a:p>
            <a:pPr marL="609600" indent="-609600">
              <a:buFontTx/>
              <a:buNone/>
            </a:pPr>
            <a:endParaRPr lang="en-GB" sz="2800" dirty="0" smtClean="0"/>
          </a:p>
        </p:txBody>
      </p:sp>
      <p:sp>
        <p:nvSpPr>
          <p:cNvPr id="12292" name="Text Box 4"/>
          <p:cNvSpPr txBox="1">
            <a:spLocks noChangeArrowheads="1"/>
          </p:cNvSpPr>
          <p:nvPr/>
        </p:nvSpPr>
        <p:spPr bwMode="auto">
          <a:xfrm>
            <a:off x="7092280" y="704890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9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3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776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1988840"/>
            <a:ext cx="7812360" cy="48006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lnSpc>
                <a:spcPct val="80000"/>
              </a:lnSpc>
              <a:buFontTx/>
              <a:buNone/>
            </a:pPr>
            <a:r>
              <a:rPr lang="en-GB" sz="2800" b="1" dirty="0" smtClean="0"/>
              <a:t>Respect the rights, choices, and dignity of each individual</a:t>
            </a:r>
          </a:p>
          <a:p>
            <a:pPr marL="990600" lvl="1" indent="-533400">
              <a:lnSpc>
                <a:spcPct val="80000"/>
              </a:lnSpc>
              <a:buFontTx/>
              <a:buNone/>
            </a:pPr>
            <a:endParaRPr lang="en-GB" sz="1200" dirty="0" smtClean="0"/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Conduct interviews in private settings</a:t>
            </a:r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US" sz="2400" dirty="0" smtClean="0"/>
              <a:t>Option of male or female staff</a:t>
            </a:r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US" sz="2400" dirty="0" smtClean="0"/>
              <a:t>Do not judge</a:t>
            </a:r>
            <a:endParaRPr lang="en-GB" sz="2400" dirty="0" smtClean="0"/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Do not re-victimize</a:t>
            </a:r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Be patient</a:t>
            </a:r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Ask only relevant, necessary questions</a:t>
            </a:r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Avoid multiple interviews </a:t>
            </a:r>
          </a:p>
          <a:p>
            <a:pPr marL="990600" lvl="1" indent="-533400">
              <a:lnSpc>
                <a:spcPct val="80000"/>
              </a:lnSpc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Do not offer access to media without consent </a:t>
            </a:r>
          </a:p>
          <a:p>
            <a:pPr marL="990600" lvl="1" indent="-533400">
              <a:lnSpc>
                <a:spcPct val="80000"/>
              </a:lnSpc>
              <a:buFontTx/>
              <a:buChar char="•"/>
            </a:pPr>
            <a:endParaRPr lang="en-GB" dirty="0" smtClean="0"/>
          </a:p>
        </p:txBody>
      </p:sp>
      <p:sp>
        <p:nvSpPr>
          <p:cNvPr id="13316" name="Text Box 4"/>
          <p:cNvSpPr txBox="1">
            <a:spLocks noChangeArrowheads="1"/>
          </p:cNvSpPr>
          <p:nvPr/>
        </p:nvSpPr>
        <p:spPr bwMode="auto">
          <a:xfrm>
            <a:off x="7020272" y="704890"/>
            <a:ext cx="755335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10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5500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75656" y="1860376"/>
            <a:ext cx="7560840" cy="495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Avoid calling authorities unless given the consent of the trafficked persons</a:t>
            </a:r>
          </a:p>
          <a:p>
            <a:pPr marL="609600" indent="-609600">
              <a:buFontTx/>
              <a:buNone/>
            </a:pPr>
            <a:endParaRPr lang="en-GB" sz="1200" b="1" dirty="0" smtClean="0"/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Always obtain explicit consent from the trafficked person before calling authorities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Well-founded reasons to avoid authorities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Discuss viable options and gain consent for actions</a:t>
            </a:r>
          </a:p>
        </p:txBody>
      </p:sp>
      <p:sp>
        <p:nvSpPr>
          <p:cNvPr id="14340" name="Text Box 4"/>
          <p:cNvSpPr txBox="1">
            <a:spLocks noChangeArrowheads="1"/>
          </p:cNvSpPr>
          <p:nvPr/>
        </p:nvSpPr>
        <p:spPr bwMode="auto">
          <a:xfrm>
            <a:off x="7020272" y="704890"/>
            <a:ext cx="717248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11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5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402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499320"/>
            <a:ext cx="7439827" cy="3810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Maintain all information in secure facilities</a:t>
            </a:r>
          </a:p>
          <a:p>
            <a:pPr marL="609600" indent="-609600">
              <a:buFontTx/>
              <a:buNone/>
            </a:pPr>
            <a:endParaRPr lang="en-GB" sz="1200" b="1" dirty="0" smtClean="0"/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Manage confidential information: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Physical information should be coded and kept in locked files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GB" sz="2400" dirty="0" smtClean="0"/>
              <a:t>Electronic information should be protected  by passwords</a:t>
            </a:r>
          </a:p>
        </p:txBody>
      </p:sp>
      <p:sp>
        <p:nvSpPr>
          <p:cNvPr id="15364" name="Text Box 4"/>
          <p:cNvSpPr txBox="1">
            <a:spLocks noChangeArrowheads="1"/>
          </p:cNvSpPr>
          <p:nvPr/>
        </p:nvSpPr>
        <p:spPr bwMode="auto">
          <a:xfrm>
            <a:off x="7020272" y="704890"/>
            <a:ext cx="755335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12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6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4387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7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17411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8" y="476672"/>
            <a:ext cx="6959600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Conclusions </a:t>
            </a:r>
          </a:p>
        </p:txBody>
      </p:sp>
      <p:sp>
        <p:nvSpPr>
          <p:cNvPr id="17412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043608" y="2420888"/>
            <a:ext cx="7619835" cy="4176464"/>
          </a:xfrm>
          <a:noFill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>
              <a:buNone/>
            </a:pPr>
            <a:r>
              <a:rPr lang="en-US" sz="2400" b="1" dirty="0" smtClean="0"/>
              <a:t>As a health provider, it is essential to be prepared: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/>
              <a:t>Know how to handle a </a:t>
            </a:r>
            <a:r>
              <a:rPr lang="en-US" sz="2400" i="1" dirty="0"/>
              <a:t>suspected</a:t>
            </a:r>
            <a:r>
              <a:rPr lang="en-US" sz="2400" dirty="0"/>
              <a:t> case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/>
              <a:t>Know how to care for a recognized trafficked person </a:t>
            </a:r>
            <a:r>
              <a:rPr lang="en-US" sz="2400" i="1" dirty="0"/>
              <a:t>referred</a:t>
            </a:r>
            <a:r>
              <a:rPr lang="en-US" sz="2400" dirty="0"/>
              <a:t> to </a:t>
            </a:r>
            <a:r>
              <a:rPr lang="en-US" sz="2400" dirty="0" smtClean="0"/>
              <a:t>you</a:t>
            </a:r>
          </a:p>
          <a:p>
            <a:pPr marL="457200" lvl="1" indent="0" algn="ctr">
              <a:buClr>
                <a:schemeClr val="tx1"/>
              </a:buClr>
              <a:buNone/>
            </a:pPr>
            <a:endParaRPr lang="en-US" sz="1800" i="1" dirty="0" smtClean="0"/>
          </a:p>
          <a:p>
            <a:pPr marL="457200" lvl="1" indent="0" algn="ctr">
              <a:buClr>
                <a:schemeClr val="tx1"/>
              </a:buClr>
              <a:buNone/>
            </a:pPr>
            <a:r>
              <a:rPr lang="en-US" sz="2400" i="1" dirty="0" smtClean="0"/>
              <a:t>Every contact with a trafficked person is a potential step towards their recovery</a:t>
            </a:r>
            <a:endParaRPr lang="en-US" sz="2400" i="1" dirty="0"/>
          </a:p>
          <a:p>
            <a:pPr marL="0" indent="0" algn="ctr">
              <a:buNone/>
            </a:pPr>
            <a:endParaRPr lang="en-US" sz="2800" b="1" dirty="0" smtClean="0"/>
          </a:p>
        </p:txBody>
      </p:sp>
    </p:spTree>
    <p:extLst>
      <p:ext uri="{BB962C8B-B14F-4D97-AF65-F5344CB8AC3E}">
        <p14:creationId xmlns:p14="http://schemas.microsoft.com/office/powerpoint/2010/main" val="2090206728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SESSION END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Guiding Principles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8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836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Course Objectives</a:t>
            </a:r>
            <a:endParaRPr lang="es-ES" sz="3600" b="1" dirty="0">
              <a:latin typeface="Antique Olive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9592" y="1700808"/>
            <a:ext cx="8244408" cy="4824536"/>
          </a:xfrm>
        </p:spPr>
        <p:txBody>
          <a:bodyPr/>
          <a:lstStyle/>
          <a:p>
            <a:pPr marL="609600" indent="-609600">
              <a:buClr>
                <a:schemeClr val="tx1"/>
              </a:buClr>
              <a:buFont typeface="+mj-lt"/>
              <a:buAutoNum type="arabicPeriod"/>
            </a:pPr>
            <a:r>
              <a:rPr lang="en-US" sz="2400" dirty="0"/>
              <a:t>Know how to handle a </a:t>
            </a:r>
            <a:r>
              <a:rPr lang="en-US" sz="2400" i="1" dirty="0"/>
              <a:t>suspected</a:t>
            </a:r>
            <a:r>
              <a:rPr lang="en-US" sz="2400" dirty="0"/>
              <a:t> </a:t>
            </a:r>
            <a:r>
              <a:rPr lang="en-US" sz="2400" dirty="0" smtClean="0"/>
              <a:t>case</a:t>
            </a:r>
            <a:endParaRPr lang="en-US" sz="2400" dirty="0"/>
          </a:p>
          <a:p>
            <a:pPr marL="609600" indent="-609600">
              <a:buClr>
                <a:schemeClr val="tx1"/>
              </a:buClr>
              <a:buFont typeface="+mj-lt"/>
              <a:buAutoNum type="arabicPeriod" startAt="2"/>
            </a:pPr>
            <a:r>
              <a:rPr lang="en-US" sz="2400" dirty="0"/>
              <a:t>Know how to care for a recognized trafficked person </a:t>
            </a:r>
            <a:r>
              <a:rPr lang="en-US" sz="2400" i="1" dirty="0"/>
              <a:t>referred</a:t>
            </a:r>
            <a:r>
              <a:rPr lang="en-US" sz="2400" dirty="0"/>
              <a:t> to </a:t>
            </a:r>
            <a:r>
              <a:rPr lang="en-US" sz="2400" dirty="0" smtClean="0"/>
              <a:t>you</a:t>
            </a:r>
          </a:p>
          <a:p>
            <a:pPr marL="0" indent="0">
              <a:buClr>
                <a:schemeClr val="tx1"/>
              </a:buClr>
              <a:buNone/>
            </a:pPr>
            <a:r>
              <a:rPr lang="en-US" sz="2400" b="1" dirty="0" smtClean="0">
                <a:solidFill>
                  <a:schemeClr val="bg1"/>
                </a:solidFill>
              </a:rPr>
              <a:t>Session Objectives</a:t>
            </a:r>
            <a:endParaRPr lang="en-GB" b="1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</a:t>
            </a:r>
            <a:r>
              <a:rPr lang="en-GB" sz="2000" dirty="0">
                <a:solidFill>
                  <a:schemeClr val="bg1"/>
                </a:solidFill>
              </a:rPr>
              <a:t>human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major health consequences of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Recognise key features of trauma-informed care </a:t>
            </a:r>
            <a:endParaRPr lang="en-GB" sz="2000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Recognize techniques for provider and patient safet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the benefits of specialized  care approaches </a:t>
            </a:r>
            <a:endParaRPr lang="en-GB" sz="2000" dirty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possibilities and limitations of role of </a:t>
            </a:r>
            <a:r>
              <a:rPr lang="en-GB" sz="2000" dirty="0" smtClean="0">
                <a:solidFill>
                  <a:schemeClr val="bg1"/>
                </a:solidFill>
              </a:rPr>
              <a:t>health care </a:t>
            </a:r>
            <a:r>
              <a:rPr lang="en-GB" sz="2000" dirty="0">
                <a:solidFill>
                  <a:schemeClr val="bg1"/>
                </a:solidFill>
              </a:rPr>
              <a:t>providers</a:t>
            </a:r>
          </a:p>
          <a:p>
            <a:pPr marL="0" indent="0">
              <a:buClr>
                <a:schemeClr val="tx1"/>
              </a:buClr>
              <a:buNone/>
            </a:pPr>
            <a:endParaRPr lang="en-GB" sz="14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2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05261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CORE MODULE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Guiding Principles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3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070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7" name="Rectangle 3"/>
          <p:cNvSpPr txBox="1">
            <a:spLocks noChangeArrowheads="1"/>
          </p:cNvSpPr>
          <p:nvPr/>
        </p:nvSpPr>
        <p:spPr bwMode="auto">
          <a:xfrm>
            <a:off x="1043608" y="476672"/>
            <a:ext cx="7128792" cy="122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marL="342900" indent="-342900"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spcBef>
                <a:spcPct val="20000"/>
              </a:spcBef>
            </a:pPr>
            <a:r>
              <a:rPr lang="en-US" sz="3200" b="1" dirty="0" smtClean="0">
                <a:latin typeface="Antique Olive" pitchFamily="34" charset="0"/>
              </a:rPr>
              <a:t>Going </a:t>
            </a:r>
            <a:r>
              <a:rPr lang="en-US" sz="3200" b="1" dirty="0">
                <a:latin typeface="Antique Olive" pitchFamily="34" charset="0"/>
              </a:rPr>
              <a:t>Beyond “Do No Harm” </a:t>
            </a:r>
            <a:endParaRPr lang="en-US" sz="3200" dirty="0">
              <a:latin typeface="Antique Olive" pitchFamily="34" charset="0"/>
            </a:endParaRPr>
          </a:p>
        </p:txBody>
      </p:sp>
      <p:sp>
        <p:nvSpPr>
          <p:cNvPr id="9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7" name="Rectangle 3"/>
          <p:cNvSpPr txBox="1">
            <a:spLocks noChangeArrowheads="1"/>
          </p:cNvSpPr>
          <p:nvPr/>
        </p:nvSpPr>
        <p:spPr bwMode="auto">
          <a:xfrm>
            <a:off x="1115616" y="3042821"/>
            <a:ext cx="6807506" cy="9622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SzPct val="101000"/>
              <a:buFont typeface="Courier New" pitchFamily="49" charset="0"/>
              <a:buChar char="o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609600" indent="-609600" algn="ctr">
              <a:buFontTx/>
              <a:buNone/>
            </a:pPr>
            <a:r>
              <a:rPr lang="en-GB" sz="2800" b="1" dirty="0" smtClean="0"/>
              <a:t>Discussion</a:t>
            </a:r>
            <a:endParaRPr lang="es-MX" sz="3000" dirty="0" smtClean="0"/>
          </a:p>
        </p:txBody>
      </p:sp>
    </p:spTree>
    <p:extLst>
      <p:ext uri="{BB962C8B-B14F-4D97-AF65-F5344CB8AC3E}">
        <p14:creationId xmlns:p14="http://schemas.microsoft.com/office/powerpoint/2010/main" val="1045832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03648" y="2362200"/>
            <a:ext cx="7537152" cy="28956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Adhere to existing recommendations</a:t>
            </a:r>
            <a:r>
              <a:rPr lang="en-GB" sz="2800" dirty="0" smtClean="0"/>
              <a:t> in the </a:t>
            </a:r>
            <a:r>
              <a:rPr lang="en-GB" sz="2800" i="1" dirty="0" smtClean="0"/>
              <a:t>WHO Ethical and Safety Recommendations for Interviewing Trafficked Women</a:t>
            </a:r>
            <a:endParaRPr lang="es-MX" sz="2800" dirty="0" smtClean="0"/>
          </a:p>
          <a:p>
            <a:pPr marL="609600" indent="-609600">
              <a:buFontTx/>
              <a:buNone/>
            </a:pPr>
            <a:endParaRPr lang="es-MX" sz="3000" dirty="0" smtClean="0"/>
          </a:p>
          <a:p>
            <a:pPr marL="609600" indent="-609600">
              <a:buFontTx/>
              <a:buNone/>
            </a:pPr>
            <a:r>
              <a:rPr lang="es-MX" sz="2800" dirty="0" smtClean="0"/>
              <a:t>http://genderviolence.lshtm.ac.uk/category/reports/</a:t>
            </a:r>
            <a:endParaRPr lang="es-MX" sz="3000" dirty="0" smtClean="0"/>
          </a:p>
          <a:p>
            <a:pPr marL="609600" indent="-609600">
              <a:buFontTx/>
              <a:buNone/>
            </a:pPr>
            <a:endParaRPr lang="es-MX" sz="3000" dirty="0" smtClean="0"/>
          </a:p>
        </p:txBody>
      </p:sp>
      <p:sp>
        <p:nvSpPr>
          <p:cNvPr id="4100" name="Text Box 4"/>
          <p:cNvSpPr txBox="1">
            <a:spLocks noChangeArrowheads="1"/>
          </p:cNvSpPr>
          <p:nvPr/>
        </p:nvSpPr>
        <p:spPr bwMode="auto">
          <a:xfrm>
            <a:off x="7236296" y="677593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1</a:t>
            </a:r>
            <a:endParaRPr lang="es-ES"/>
          </a:p>
        </p:txBody>
      </p:sp>
      <p:sp>
        <p:nvSpPr>
          <p:cNvPr id="2" name="Rectangle 1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5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273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332038"/>
            <a:ext cx="7507560" cy="3687762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lnSpc>
                <a:spcPct val="90000"/>
              </a:lnSpc>
              <a:buFontTx/>
              <a:buNone/>
            </a:pPr>
            <a:r>
              <a:rPr lang="en-US" sz="2800" b="1" dirty="0" smtClean="0"/>
              <a:t>Treat all contact with trafficked persons as a potential step towards improving their health</a:t>
            </a:r>
            <a:r>
              <a:rPr lang="en-US" sz="2800" dirty="0" smtClean="0"/>
              <a:t> </a:t>
            </a:r>
          </a:p>
          <a:p>
            <a:pPr marL="609600" indent="-609600">
              <a:lnSpc>
                <a:spcPct val="90000"/>
              </a:lnSpc>
              <a:buFontTx/>
              <a:buNone/>
            </a:pPr>
            <a:endParaRPr lang="en-US" sz="1050" dirty="0" smtClean="0"/>
          </a:p>
          <a:p>
            <a:pPr marL="609600" indent="-609600">
              <a:lnSpc>
                <a:spcPct val="90000"/>
              </a:lnSpc>
              <a:buFontTx/>
              <a:buNone/>
            </a:pPr>
            <a:r>
              <a:rPr lang="en-US" sz="2800" dirty="0" smtClean="0"/>
              <a:t>      Each encounter with a trafficked person can have positive or negative effects on their health and well-being </a:t>
            </a:r>
          </a:p>
          <a:p>
            <a:pPr marL="609600" indent="-609600">
              <a:lnSpc>
                <a:spcPct val="90000"/>
              </a:lnSpc>
              <a:buFontTx/>
              <a:buNone/>
            </a:pPr>
            <a:endParaRPr lang="en-US" sz="2800" dirty="0" smtClean="0"/>
          </a:p>
          <a:p>
            <a:pPr marL="609600" indent="-609600">
              <a:lnSpc>
                <a:spcPct val="90000"/>
              </a:lnSpc>
              <a:buFontTx/>
              <a:buNone/>
            </a:pPr>
            <a:r>
              <a:rPr lang="en-US" sz="2600" dirty="0" smtClean="0"/>
              <a:t>      </a:t>
            </a:r>
          </a:p>
        </p:txBody>
      </p:sp>
      <p:sp>
        <p:nvSpPr>
          <p:cNvPr id="5124" name="Text Box 4"/>
          <p:cNvSpPr txBox="1">
            <a:spLocks noChangeArrowheads="1"/>
          </p:cNvSpPr>
          <p:nvPr/>
        </p:nvSpPr>
        <p:spPr bwMode="auto">
          <a:xfrm>
            <a:off x="7092280" y="704890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2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6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7219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332038"/>
            <a:ext cx="7541427" cy="4068762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US" sz="2800" b="1" dirty="0" smtClean="0"/>
              <a:t>Prioritize the safety of trafficked persons, self and staff</a:t>
            </a:r>
            <a:r>
              <a:rPr lang="es-MX" sz="2800" dirty="0" smtClean="0"/>
              <a:t> </a:t>
            </a:r>
          </a:p>
          <a:p>
            <a:pPr marL="609600" indent="-609600">
              <a:buFontTx/>
              <a:buNone/>
            </a:pPr>
            <a:endParaRPr lang="en-US" sz="1100" dirty="0" smtClean="0"/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US" sz="2800" dirty="0" smtClean="0"/>
              <a:t>Assess risks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US" sz="2800" dirty="0" smtClean="0"/>
              <a:t>Make informed decisions</a:t>
            </a:r>
          </a:p>
          <a:p>
            <a:pPr marL="990600" lvl="1" indent="-533400">
              <a:buClr>
                <a:schemeClr val="tx1"/>
              </a:buClr>
              <a:buFontTx/>
              <a:buChar char="•"/>
            </a:pPr>
            <a:r>
              <a:rPr lang="en-US" sz="2800" dirty="0" smtClean="0"/>
              <a:t>Be aware of safety concerns and potential dangers</a:t>
            </a:r>
          </a:p>
          <a:p>
            <a:pPr marL="609600" indent="-609600">
              <a:buFontTx/>
              <a:buNone/>
            </a:pPr>
            <a:endParaRPr lang="en-US" sz="2800" dirty="0" smtClean="0"/>
          </a:p>
          <a:p>
            <a:pPr marL="609600" indent="-609600"/>
            <a:endParaRPr lang="en-US" sz="2400" dirty="0" smtClean="0"/>
          </a:p>
          <a:p>
            <a:pPr marL="609600" indent="-609600">
              <a:buFontTx/>
              <a:buNone/>
            </a:pPr>
            <a:endParaRPr lang="en-US" sz="2400" dirty="0" smtClean="0"/>
          </a:p>
        </p:txBody>
      </p:sp>
      <p:sp>
        <p:nvSpPr>
          <p:cNvPr id="6148" name="Text Box 4"/>
          <p:cNvSpPr txBox="1">
            <a:spLocks noChangeArrowheads="1"/>
          </p:cNvSpPr>
          <p:nvPr/>
        </p:nvSpPr>
        <p:spPr bwMode="auto">
          <a:xfrm>
            <a:off x="7020272" y="704890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3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7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9892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03648" y="2286000"/>
            <a:ext cx="7740352" cy="330324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US" sz="2800" b="1" dirty="0" smtClean="0"/>
              <a:t>Provide respectful, equitable care that does not discriminate</a:t>
            </a:r>
          </a:p>
          <a:p>
            <a:pPr marL="609600" indent="-609600">
              <a:buFontTx/>
              <a:buNone/>
            </a:pPr>
            <a:endParaRPr lang="en-US" sz="1400" dirty="0" smtClean="0"/>
          </a:p>
          <a:p>
            <a:pPr marL="609600" indent="-609600">
              <a:buFontTx/>
              <a:buNone/>
            </a:pPr>
            <a:r>
              <a:rPr lang="en-US" sz="2600" dirty="0" smtClean="0"/>
              <a:t>	</a:t>
            </a:r>
            <a:r>
              <a:rPr lang="en-US" sz="2800" dirty="0" smtClean="0"/>
              <a:t>Health care should respect the rights and dignity of those who are vulnerable</a:t>
            </a:r>
          </a:p>
          <a:p>
            <a:pPr marL="609600" indent="-609600"/>
            <a:endParaRPr lang="en-US" sz="2600" dirty="0" smtClean="0"/>
          </a:p>
        </p:txBody>
      </p:sp>
      <p:sp>
        <p:nvSpPr>
          <p:cNvPr id="7172" name="Text Box 4"/>
          <p:cNvSpPr txBox="1">
            <a:spLocks noChangeArrowheads="1"/>
          </p:cNvSpPr>
          <p:nvPr/>
        </p:nvSpPr>
        <p:spPr bwMode="auto">
          <a:xfrm>
            <a:off x="7092280" y="704890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4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8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21450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03648" y="2362200"/>
            <a:ext cx="7537152" cy="29718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609600" indent="-609600">
              <a:buFontTx/>
              <a:buNone/>
            </a:pPr>
            <a:r>
              <a:rPr lang="en-GB" sz="2800" b="1" dirty="0" smtClean="0"/>
              <a:t>Be prepared with referral information and contact details for trusted support persons</a:t>
            </a:r>
          </a:p>
          <a:p>
            <a:pPr marL="609600" indent="-609600">
              <a:buFontTx/>
              <a:buNone/>
            </a:pPr>
            <a:endParaRPr lang="en-GB" sz="1400" b="1" dirty="0" smtClean="0"/>
          </a:p>
          <a:p>
            <a:pPr marL="609600" indent="-609600">
              <a:buFontTx/>
              <a:buNone/>
            </a:pPr>
            <a:r>
              <a:rPr lang="en-GB" sz="2800" dirty="0" smtClean="0"/>
              <a:t>      Shelter, social services, counselling, legal advocacy and law enforcement. </a:t>
            </a:r>
          </a:p>
        </p:txBody>
      </p:sp>
      <p:sp>
        <p:nvSpPr>
          <p:cNvPr id="8196" name="Text Box 4"/>
          <p:cNvSpPr txBox="1">
            <a:spLocks noChangeArrowheads="1"/>
          </p:cNvSpPr>
          <p:nvPr/>
        </p:nvSpPr>
        <p:spPr bwMode="auto">
          <a:xfrm>
            <a:off x="7126336" y="630093"/>
            <a:ext cx="470000" cy="707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CR"/>
              <a:t>5</a:t>
            </a:r>
            <a:endParaRPr lang="es-ES"/>
          </a:p>
        </p:txBody>
      </p:sp>
      <p:sp>
        <p:nvSpPr>
          <p:cNvPr id="5" name="Rectangle 4"/>
          <p:cNvSpPr/>
          <p:nvPr/>
        </p:nvSpPr>
        <p:spPr>
          <a:xfrm>
            <a:off x="1043608" y="766445"/>
            <a:ext cx="7056784" cy="64633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Bef>
                <a:spcPct val="20000"/>
              </a:spcBef>
            </a:pPr>
            <a:r>
              <a:rPr lang="en-US" sz="3600" b="1" dirty="0" smtClean="0">
                <a:latin typeface="Antique Olive" pitchFamily="34" charset="0"/>
              </a:rPr>
              <a:t>Guiding Principle</a:t>
            </a:r>
            <a:endParaRPr lang="en-US" sz="3600" dirty="0">
              <a:latin typeface="Antique Olive" pitchFamily="34" charset="0"/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9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93276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ummer">
  <a:themeElements>
    <a:clrScheme name="Summer">
      <a:dk1>
        <a:sysClr val="windowText" lastClr="000000"/>
      </a:dk1>
      <a:lt1>
        <a:sysClr val="window" lastClr="FFFFFF"/>
      </a:lt1>
      <a:dk2>
        <a:srgbClr val="E89117"/>
      </a:dk2>
      <a:lt2>
        <a:srgbClr val="FEDD78"/>
      </a:lt2>
      <a:accent1>
        <a:srgbClr val="A1B633"/>
      </a:accent1>
      <a:accent2>
        <a:srgbClr val="C4D73F"/>
      </a:accent2>
      <a:accent3>
        <a:srgbClr val="FFCE2D"/>
      </a:accent3>
      <a:accent4>
        <a:srgbClr val="FFA600"/>
      </a:accent4>
      <a:accent5>
        <a:srgbClr val="ED5E00"/>
      </a:accent5>
      <a:accent6>
        <a:srgbClr val="C62D03"/>
      </a:accent6>
      <a:hlink>
        <a:srgbClr val="408080"/>
      </a:hlink>
      <a:folHlink>
        <a:srgbClr val="5EAEAE"/>
      </a:folHlink>
    </a:clrScheme>
    <a:fontScheme name="Summer">
      <a:maj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Summer">
      <a:fillStyleLst>
        <a:solidFill>
          <a:schemeClr val="phClr"/>
        </a:solidFill>
        <a:gradFill rotWithShape="1">
          <a:gsLst>
            <a:gs pos="0">
              <a:schemeClr val="phClr">
                <a:tint val="70000"/>
                <a:lumMod val="110000"/>
              </a:schemeClr>
            </a:gs>
            <a:gs pos="100000">
              <a:schemeClr val="phClr">
                <a:tint val="90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satMod val="120000"/>
                <a:lumMod val="110000"/>
              </a:schemeClr>
            </a:gs>
            <a:gs pos="100000">
              <a:schemeClr val="phClr">
                <a:shade val="90000"/>
                <a:lumMod val="90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88900" dist="38100" dir="5400000" algn="ctr" rotWithShape="0">
              <a:srgbClr val="000000">
                <a:alpha val="65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5400000"/>
            </a:lightRig>
          </a:scene3d>
          <a:sp3d>
            <a:bevelT w="25400" h="381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2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30000"/>
                <a:lumMod val="10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>
            <a:alpha val="97000"/>
          </a:schemeClr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>
            <a:alpha val="97000"/>
          </a:schemeClr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C101972873[[fn=Summer]]</Template>
  <TotalTime>884</TotalTime>
  <Words>499</Words>
  <Application>Microsoft Office PowerPoint</Application>
  <PresentationFormat>On-screen Show (4:3)</PresentationFormat>
  <Paragraphs>124</Paragraphs>
  <Slides>18</Slides>
  <Notes>18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18</vt:i4>
      </vt:variant>
    </vt:vector>
  </HeadingPairs>
  <TitlesOfParts>
    <vt:vector size="20" baseType="lpstr">
      <vt:lpstr>Summer</vt:lpstr>
      <vt:lpstr>Default Design</vt:lpstr>
      <vt:lpstr>PowerPoint Presentation</vt:lpstr>
      <vt:lpstr>Course Objectiv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Conclusions 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ring for Trafficked Persons</dc:title>
  <dc:creator>BORLAND Rosilyne</dc:creator>
  <cp:lastModifiedBy>BORLAND Rosilyne</cp:lastModifiedBy>
  <cp:revision>110</cp:revision>
  <dcterms:created xsi:type="dcterms:W3CDTF">2012-05-17T16:24:19Z</dcterms:created>
  <dcterms:modified xsi:type="dcterms:W3CDTF">2013-01-07T12:25:33Z</dcterms:modified>
</cp:coreProperties>
</file>